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78" r:id="rId2"/>
    <p:sldId id="270" r:id="rId3"/>
    <p:sldId id="271" r:id="rId4"/>
    <p:sldId id="272" r:id="rId5"/>
    <p:sldId id="276" r:id="rId6"/>
    <p:sldId id="274" r:id="rId7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51"/>
    <a:srgbClr val="009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38" autoAdjust="0"/>
    <p:restoredTop sz="80988"/>
  </p:normalViewPr>
  <p:slideViewPr>
    <p:cSldViewPr snapToGrid="0" snapToObjects="1" showGuides="1">
      <p:cViewPr varScale="1">
        <p:scale>
          <a:sx n="114" d="100"/>
          <a:sy n="114" d="100"/>
        </p:scale>
        <p:origin x="480" y="102"/>
      </p:cViewPr>
      <p:guideLst>
        <p:guide orient="horz" pos="4315"/>
        <p:guide pos="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Anirban" userId="beb374dd-c17a-4851-a293-48dd327a1c1a" providerId="ADAL" clId="{BA4CE0FF-82F6-4AD2-BF56-5A9C7A7666DF}"/>
    <pc:docChg chg="custSel delSld modSld">
      <pc:chgData name="Chakraborty, Anirban" userId="beb374dd-c17a-4851-a293-48dd327a1c1a" providerId="ADAL" clId="{BA4CE0FF-82F6-4AD2-BF56-5A9C7A7666DF}" dt="2023-09-19T13:15:03.020" v="1" actId="47"/>
      <pc:docMkLst>
        <pc:docMk/>
      </pc:docMkLst>
      <pc:sldChg chg="delSp mod">
        <pc:chgData name="Chakraborty, Anirban" userId="beb374dd-c17a-4851-a293-48dd327a1c1a" providerId="ADAL" clId="{BA4CE0FF-82F6-4AD2-BF56-5A9C7A7666DF}" dt="2023-09-19T13:14:29.354" v="0" actId="478"/>
        <pc:sldMkLst>
          <pc:docMk/>
          <pc:sldMk cId="550479794" sldId="278"/>
        </pc:sldMkLst>
        <pc:spChg chg="del">
          <ac:chgData name="Chakraborty, Anirban" userId="beb374dd-c17a-4851-a293-48dd327a1c1a" providerId="ADAL" clId="{BA4CE0FF-82F6-4AD2-BF56-5A9C7A7666DF}" dt="2023-09-19T13:14:29.354" v="0" actId="478"/>
          <ac:spMkLst>
            <pc:docMk/>
            <pc:sldMk cId="550479794" sldId="278"/>
            <ac:spMk id="6" creationId="{00000000-0000-0000-0000-000000000000}"/>
          </ac:spMkLst>
        </pc:spChg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3002076954" sldId="279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3852428335" sldId="280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1026364918" sldId="281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2329365240" sldId="282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438658365" sldId="284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1305156795" sldId="285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4028044274" sldId="286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256142667" sldId="287"/>
        </pc:sldMkLst>
      </pc:sldChg>
      <pc:sldChg chg="del">
        <pc:chgData name="Chakraborty, Anirban" userId="beb374dd-c17a-4851-a293-48dd327a1c1a" providerId="ADAL" clId="{BA4CE0FF-82F6-4AD2-BF56-5A9C7A7666DF}" dt="2023-09-19T13:15:03.020" v="1" actId="47"/>
        <pc:sldMkLst>
          <pc:docMk/>
          <pc:sldMk cId="3421195017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E8D3B8AE-E6A7-C943-834B-509E182B2575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F048A57D-F6E1-034D-9BC0-9C2FC71C8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27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2D4F7-2021-A642-B0CE-338B12301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CCA26C-5B50-B94F-82D6-8760696C27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6B55-454B-624D-A8D3-B1248D1B5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245B3-23F0-9445-AE77-CA1A1FD8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6163F-C787-3142-915E-C39148617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8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E13B3-C6AC-5A43-9ACB-B4BA394C2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46718-2042-F04B-9FAD-3A485529EF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4F6B8-0A0A-AE4D-A494-4C95AE6C0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5348F-7B1A-4B46-B822-6736B2938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3BCF7-4449-3A4E-B494-1AFC21D8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DFC63B-84F7-4243-A5B4-1EC304FD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AB81E-D3C6-C94C-A282-3BF98AFCD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AD0D-7288-654F-956C-AD2593D6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4BA3-1568-7241-BDAB-8CA5920E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64E63-C144-C745-A366-8399D4020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4461C-9762-2342-A51E-38E476E7C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24E9A-EA4E-1744-AF11-1D43DC789A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C2680-0E9C-3144-862B-AFB3E69D4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A7B78-FC12-D747-AAC1-F9FAD2ADC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D220A-A23D-CA41-995A-E6A03A04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78E1-7996-144E-B8D4-476A68562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0D34C9-D05D-1E49-84C5-6333390D5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6A32-BAB0-E645-8BDF-589DD81C4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ABB79-D302-C944-A688-1B470D9D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1689D-4A8C-8E46-82E9-B3534632D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0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BDA4-9FCB-EE4C-810C-5C5661A10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1E0D0-4ABC-714F-89BF-8FCDBAE746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2CB25A-C5E7-D94D-B661-81D2A868C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77595-6DF1-794D-A232-1C9958ED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9CD3-9B4C-504C-879A-B4107E76E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AA483B-07C6-2043-8671-5B808FCA0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7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0A434-9C06-A042-A4F7-732F4398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2AE10-BF72-0049-A0E4-F4BA1C992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8F7D1D-D036-B44B-9630-10A6978CF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2EEC0-124E-EC46-8D02-E81AD515A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E4BCE2-4DE2-D24C-86A9-F1C6DF724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3A7F2-94A9-B349-9B3B-D0F826A3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CC8104-22AE-3045-9A1A-2FA341AFA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E858AB-36F4-684B-A9FE-18BB4BC0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DAA0F-1B23-4344-A407-89B3D606D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CE5D9-E60A-9F46-8E26-6AB7D339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D3E93-5CF8-F348-A2F5-35068A6A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692F73-EA23-F34A-B504-CD619EC2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9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41EA2-0F06-6444-967C-B8D532FB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0B9B18-2F70-1048-BBA6-F718B570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47B7B-3038-7141-BB16-7C04389F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67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1EAD8-56A1-5E41-B7CA-A0A401B02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040C8-CB84-0B4E-88B3-B0C73BBC4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22BAF-B99A-4E49-A59A-614A4939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12B9D-5CAD-3A41-8FBA-DC8923E9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579BE-E6ED-F945-ABE3-80AAC0A4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ED946-F4A8-C24C-A6DA-BD2627D6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44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22CB-3D02-1B4F-841E-DE018BDD6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453081-0A59-1244-B45A-AA0D2D67F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4762F7-554D-E34C-A3DD-AE030B3D4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6D7CA-F115-1B41-8DF9-AC61BF628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61EFA-B3A1-C442-89E4-0AE92344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531CB6-9230-FB4A-84ED-FD6D385D0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8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AF5F41-1579-A24F-A466-EE012090C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AB8E2-733C-0C44-8972-CE6D7845E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5B314-1FC4-DC40-8D1B-57D2252FED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C9C2-2FD4-D142-8295-6FFB674C2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9995-9E3D-E54E-A29C-ECE6B5776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662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5056" y="972312"/>
            <a:ext cx="5961888" cy="491337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686425" y="66675"/>
            <a:ext cx="904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2</a:t>
            </a:r>
          </a:p>
        </p:txBody>
      </p:sp>
      <p:sp>
        <p:nvSpPr>
          <p:cNvPr id="2" name="Rectangle 1"/>
          <p:cNvSpPr/>
          <p:nvPr/>
        </p:nvSpPr>
        <p:spPr>
          <a:xfrm>
            <a:off x="2495550" y="436007"/>
            <a:ext cx="3105150" cy="55933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4797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8677" y="2214562"/>
            <a:ext cx="5621485" cy="24288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85750" y="2385478"/>
            <a:ext cx="3636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p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KP IP PNKP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4393" y="3977041"/>
            <a:ext cx="34556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ottom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XN3 IP PNKP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B)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4178893" y="15376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4469792" y="15388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4821197" y="15388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820711" y="1470507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5142636" y="15388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5459857" y="15388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8920162" y="2384277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8918734" y="2750322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9203820" y="2270913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9203820" y="2631699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186728" y="1904869"/>
            <a:ext cx="43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6358576" y="155374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PNK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237287" y="49973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4528186" y="49985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4836861" y="49985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879105" y="5032688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5132662" y="49985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5441337" y="49985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5951980" y="498995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6416970" y="5013375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PNK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8927281" y="3844184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8925853" y="4210229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9210939" y="3730820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9210939" y="4091606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4768894" y="1495514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399862" y="1494089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4852926" y="5476435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5442588" y="5467889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4674662" y="1026793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327167" y="1025545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827062" y="5486278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369148" y="5493424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627066" y="6288768"/>
            <a:ext cx="4677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h the blots are probed with </a:t>
            </a:r>
            <a:r>
              <a:rPr lang="en-US" b="1" dirty="0">
                <a:solidFill>
                  <a:srgbClr val="FF0000"/>
                </a:solidFill>
              </a:rPr>
              <a:t>PNKP</a:t>
            </a:r>
            <a:r>
              <a:rPr lang="en-US" dirty="0"/>
              <a:t> antibody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466257" y="146524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2A-B</a:t>
            </a:r>
          </a:p>
        </p:txBody>
      </p:sp>
      <p:sp>
        <p:nvSpPr>
          <p:cNvPr id="3" name="Rectangle 2"/>
          <p:cNvSpPr/>
          <p:nvPr/>
        </p:nvSpPr>
        <p:spPr>
          <a:xfrm>
            <a:off x="4395047" y="2394023"/>
            <a:ext cx="1679884" cy="4740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5218211" y="2796191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49" name="Rectangle 48"/>
          <p:cNvSpPr/>
          <p:nvPr/>
        </p:nvSpPr>
        <p:spPr>
          <a:xfrm>
            <a:off x="4395047" y="3879923"/>
            <a:ext cx="1679884" cy="47407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4395046" y="1904869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 3    4    5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452196" y="4581394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3    4   5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145936" y="3523188"/>
            <a:ext cx="2885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51" name="TextBox 50"/>
          <p:cNvSpPr txBox="1"/>
          <p:nvPr/>
        </p:nvSpPr>
        <p:spPr>
          <a:xfrm rot="16200000">
            <a:off x="5893586" y="156584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</p:spTree>
    <p:extLst>
      <p:ext uri="{BB962C8B-B14F-4D97-AF65-F5344CB8AC3E}">
        <p14:creationId xmlns:p14="http://schemas.microsoft.com/office/powerpoint/2010/main" val="1499400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7051" y="2696045"/>
            <a:ext cx="5401524" cy="220084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4178893" y="205897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4469792" y="206017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4778467" y="206017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3795073" y="1991805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074268" y="206017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411518" y="206017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8672332" y="2803023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8670904" y="3117792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5874536" y="205162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007266" y="2696045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973081" y="2360336"/>
            <a:ext cx="43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6358576" y="2075044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TXN3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4743256" y="2016812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314402" y="2015387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4674662" y="1548091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216748" y="1546691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134735" y="5270774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4459818" y="525488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4768493" y="52719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802191" y="5212154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5081386" y="5271974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5372969" y="5271973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5830378" y="5263424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6314418" y="528684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TXN3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4750374" y="5749907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5340036" y="5741361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724510" y="5759750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266596" y="5749804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9015812" y="2994681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9" name="Straight Connector 38"/>
          <p:cNvCxnSpPr/>
          <p:nvPr/>
        </p:nvCxnSpPr>
        <p:spPr>
          <a:xfrm>
            <a:off x="8679450" y="3998014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8678022" y="4312783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9014384" y="3891036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9022930" y="4189672"/>
            <a:ext cx="34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80975" y="2931782"/>
            <a:ext cx="3338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p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KP IP ATXN3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A)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-28914" y="4279703"/>
            <a:ext cx="35482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ottom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XN3 IP ATXN3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B)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334648" y="6389536"/>
            <a:ext cx="4745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h the blots are probed with </a:t>
            </a:r>
            <a:r>
              <a:rPr lang="en-US" b="1" dirty="0">
                <a:solidFill>
                  <a:srgbClr val="FF0000"/>
                </a:solidFill>
              </a:rPr>
              <a:t>ATXN3</a:t>
            </a:r>
            <a:r>
              <a:rPr lang="en-US" dirty="0"/>
              <a:t> antibody. </a:t>
            </a:r>
          </a:p>
        </p:txBody>
      </p:sp>
      <p:sp>
        <p:nvSpPr>
          <p:cNvPr id="45" name="Rectangle 44"/>
          <p:cNvSpPr/>
          <p:nvPr/>
        </p:nvSpPr>
        <p:spPr>
          <a:xfrm>
            <a:off x="4318847" y="2813123"/>
            <a:ext cx="1679884" cy="4740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5218211" y="3291491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47" name="Rectangle 46"/>
          <p:cNvSpPr/>
          <p:nvPr/>
        </p:nvSpPr>
        <p:spPr>
          <a:xfrm>
            <a:off x="4316959" y="4049610"/>
            <a:ext cx="1679884" cy="4740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Box 47"/>
          <p:cNvSpPr txBox="1"/>
          <p:nvPr/>
        </p:nvSpPr>
        <p:spPr>
          <a:xfrm>
            <a:off x="4399761" y="277616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2A-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303238" y="4445746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395046" y="2419219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3    4    5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385521" y="4886194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3    4   5</a:t>
            </a:r>
          </a:p>
        </p:txBody>
      </p:sp>
    </p:spTree>
    <p:extLst>
      <p:ext uri="{BB962C8B-B14F-4D97-AF65-F5344CB8AC3E}">
        <p14:creationId xmlns:p14="http://schemas.microsoft.com/office/powerpoint/2010/main" val="13623573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2672" y="2450507"/>
            <a:ext cx="5346655" cy="195698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4383996" y="181968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4674895" y="182088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4983570" y="182088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4000176" y="1752520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5279371" y="182088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616621" y="1820885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6089164" y="1812336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6563679" y="1835759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Li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II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4948359" y="1777527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5545143" y="1776102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879765" y="1308806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447489" y="1315952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8774883" y="2879937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9075632" y="2756826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9075632" y="2212520"/>
            <a:ext cx="43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8773455" y="3904013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9074204" y="3780902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95275" y="2756825"/>
            <a:ext cx="31103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p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KP IP </a:t>
            </a:r>
            <a:r>
              <a:rPr lang="en-US" sz="1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g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I</a:t>
            </a:r>
            <a:r>
              <a:rPr lang="el-G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n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A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225101" y="6030864"/>
            <a:ext cx="4170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h the blots are probed with </a:t>
            </a:r>
            <a:r>
              <a:rPr lang="en-US" b="1" dirty="0" err="1">
                <a:solidFill>
                  <a:srgbClr val="FF0000"/>
                </a:solidFill>
              </a:rPr>
              <a:t>Lig</a:t>
            </a:r>
            <a:r>
              <a:rPr lang="en-US" b="1" dirty="0">
                <a:solidFill>
                  <a:srgbClr val="FF0000"/>
                </a:solidFill>
              </a:rPr>
              <a:t> III</a:t>
            </a:r>
            <a:r>
              <a:rPr lang="el-GR" b="1" dirty="0">
                <a:solidFill>
                  <a:srgbClr val="FF0000"/>
                </a:solidFill>
              </a:rPr>
              <a:t>α</a:t>
            </a:r>
            <a:r>
              <a:rPr lang="en-US" dirty="0"/>
              <a:t> Ab.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466257" y="146524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2A-B</a:t>
            </a:r>
          </a:p>
        </p:txBody>
      </p:sp>
      <p:sp>
        <p:nvSpPr>
          <p:cNvPr id="38" name="Rectangle 37"/>
          <p:cNvSpPr/>
          <p:nvPr/>
        </p:nvSpPr>
        <p:spPr>
          <a:xfrm>
            <a:off x="4490296" y="2574998"/>
            <a:ext cx="1702849" cy="423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5421851" y="2950690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595071" y="2171569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3    4    5</a:t>
            </a:r>
          </a:p>
        </p:txBody>
      </p:sp>
    </p:spTree>
    <p:extLst>
      <p:ext uri="{BB962C8B-B14F-4D97-AF65-F5344CB8AC3E}">
        <p14:creationId xmlns:p14="http://schemas.microsoft.com/office/powerpoint/2010/main" val="31097447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2448" t="22425" r="9234" b="41746"/>
          <a:stretch/>
        </p:blipFill>
        <p:spPr>
          <a:xfrm>
            <a:off x="3862699" y="2230453"/>
            <a:ext cx="5537675" cy="206808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4221624" y="161458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4512523" y="161578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4821198" y="161578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3828858" y="1547421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5116999" y="161578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5425674" y="161578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888692" y="1607237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6401307" y="1630660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Li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II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4785987" y="1512606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5357133" y="1511181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717393" y="1043885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305725" y="1043005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4331293" y="46042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4647830" y="4588310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4956505" y="460540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930381" y="4545582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5269398" y="4605402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5588106" y="4605400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6066054" y="4568820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6519522" y="4594355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P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>
            <a:off x="4938386" y="5083335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528048" y="5074789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4912522" y="5093178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XN3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454608" y="5100324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/>
          <p:cNvCxnSpPr/>
          <p:nvPr/>
        </p:nvCxnSpPr>
        <p:spPr>
          <a:xfrm>
            <a:off x="9407278" y="2615016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9716573" y="2491905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9716573" y="1947599"/>
            <a:ext cx="43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>
            <a:off x="9414396" y="3562178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9783511" y="3439067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9405852" y="2271756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9715147" y="2148645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38" name="Rectangle 37"/>
          <p:cNvSpPr/>
          <p:nvPr/>
        </p:nvSpPr>
        <p:spPr>
          <a:xfrm>
            <a:off x="4353100" y="2422292"/>
            <a:ext cx="1702849" cy="423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/>
          <p:cNvSpPr txBox="1"/>
          <p:nvPr/>
        </p:nvSpPr>
        <p:spPr>
          <a:xfrm>
            <a:off x="5284655" y="2797984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40" name="Rectangle 39"/>
          <p:cNvSpPr/>
          <p:nvPr/>
        </p:nvSpPr>
        <p:spPr>
          <a:xfrm>
            <a:off x="4433146" y="3660848"/>
            <a:ext cx="1702849" cy="423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5364701" y="3988915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964962" y="2518828"/>
            <a:ext cx="299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p part corresponds to </a:t>
            </a:r>
            <a:r>
              <a:rPr lang="en-US" sz="1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g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II</a:t>
            </a:r>
            <a:r>
              <a:rPr lang="el-G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ATXN3 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B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861369" y="3838174"/>
            <a:ext cx="3188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ottom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 </a:t>
            </a:r>
            <a:r>
              <a:rPr lang="el-G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ATXN3 IP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B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327167" y="157294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2A-B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442671" y="1952494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3    4   5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576021" y="4248019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 2   3    4    5</a:t>
            </a:r>
          </a:p>
        </p:txBody>
      </p:sp>
    </p:spTree>
    <p:extLst>
      <p:ext uri="{BB962C8B-B14F-4D97-AF65-F5344CB8AC3E}">
        <p14:creationId xmlns:p14="http://schemas.microsoft.com/office/powerpoint/2010/main" val="25737548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72808" y="2680205"/>
            <a:ext cx="5651482" cy="224961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6200000">
            <a:off x="4221629" y="201624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4512528" y="201744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4821203" y="201744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3829263" y="1949075"/>
            <a:ext cx="87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5126529" y="201744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451317" y="201744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888697" y="2008891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6401312" y="2032314"/>
            <a:ext cx="734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P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4785992" y="1974082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5357138" y="1972657"/>
            <a:ext cx="4525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717398" y="1505361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NK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259484" y="1512507"/>
            <a:ext cx="88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9039804" y="3221772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9349099" y="3098661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347673" y="2435185"/>
            <a:ext cx="43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9038378" y="2878512"/>
            <a:ext cx="2665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9347673" y="2755401"/>
            <a:ext cx="47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066783" y="5885228"/>
            <a:ext cx="39542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h the blots are probed with </a:t>
            </a:r>
            <a:r>
              <a:rPr lang="en-US" b="1" dirty="0">
                <a:solidFill>
                  <a:srgbClr val="FF0000"/>
                </a:solidFill>
              </a:rPr>
              <a:t>Pol </a:t>
            </a:r>
            <a:r>
              <a:rPr lang="el-GR" b="1" dirty="0">
                <a:solidFill>
                  <a:srgbClr val="FF0000"/>
                </a:solidFill>
              </a:rPr>
              <a:t>β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/>
              <a:t>Ab.</a:t>
            </a:r>
          </a:p>
        </p:txBody>
      </p:sp>
      <p:sp>
        <p:nvSpPr>
          <p:cNvPr id="25" name="Rectangle 24"/>
          <p:cNvSpPr/>
          <p:nvPr/>
        </p:nvSpPr>
        <p:spPr>
          <a:xfrm>
            <a:off x="4387154" y="2964259"/>
            <a:ext cx="1702849" cy="423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5318709" y="3339951"/>
            <a:ext cx="1097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3375" y="3023348"/>
            <a:ext cx="3039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p part corresponds to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KP IP Pol </a:t>
            </a:r>
            <a:r>
              <a:rPr lang="el-G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nel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A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870497" y="213471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2A-B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480771" y="2400169"/>
            <a:ext cx="1679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  2   3    4    5</a:t>
            </a:r>
          </a:p>
        </p:txBody>
      </p:sp>
    </p:spTree>
    <p:extLst>
      <p:ext uri="{BB962C8B-B14F-4D97-AF65-F5344CB8AC3E}">
        <p14:creationId xmlns:p14="http://schemas.microsoft.com/office/powerpoint/2010/main" val="3096922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xo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AD84C6"/>
      </a:accent1>
      <a:accent2>
        <a:srgbClr val="8784C7"/>
      </a:accent2>
      <a:accent3>
        <a:srgbClr val="5D739A"/>
      </a:accent3>
      <a:accent4>
        <a:srgbClr val="6997AF"/>
      </a:accent4>
      <a:accent5>
        <a:srgbClr val="84ACB6"/>
      </a:accent5>
      <a:accent6>
        <a:srgbClr val="6F8183"/>
      </a:accent6>
      <a:hlink>
        <a:srgbClr val="69A020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1</TotalTime>
  <Words>331</Words>
  <Application>Microsoft Office PowerPoint</Application>
  <PresentationFormat>Widescreen</PresentationFormat>
  <Paragraphs>13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a Sofia da Silva Correia</dc:creator>
  <cp:lastModifiedBy>Chakraborty, Anirban</cp:lastModifiedBy>
  <cp:revision>150</cp:revision>
  <cp:lastPrinted>2023-08-29T23:30:28Z</cp:lastPrinted>
  <dcterms:created xsi:type="dcterms:W3CDTF">2021-02-24T12:59:59Z</dcterms:created>
  <dcterms:modified xsi:type="dcterms:W3CDTF">2023-09-19T13:15:13Z</dcterms:modified>
</cp:coreProperties>
</file>